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zh-CN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60" d="100"/>
          <a:sy n="60" d="100"/>
        </p:scale>
        <p:origin x="-2328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zh-CN" altLang="en-US" smtClean="0"/>
              <a:t>单击此处编辑母版副标题样式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36EA1-2526-C744-AD56-14DE8A8A7FBC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85DF5-F796-DC4E-85AF-D53AD357015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8576153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36EA1-2526-C744-AD56-14DE8A8A7FBC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85DF5-F796-DC4E-85AF-D53AD357015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0113375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36EA1-2526-C744-AD56-14DE8A8A7FBC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85DF5-F796-DC4E-85AF-D53AD357015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7460026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36EA1-2526-C744-AD56-14DE8A8A7FBC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85DF5-F796-DC4E-85AF-D53AD357015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9990621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36EA1-2526-C744-AD56-14DE8A8A7FBC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85DF5-F796-DC4E-85AF-D53AD357015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4541673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36EA1-2526-C744-AD56-14DE8A8A7FBC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85DF5-F796-DC4E-85AF-D53AD357015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3780189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36EA1-2526-C744-AD56-14DE8A8A7FBC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幻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85DF5-F796-DC4E-85AF-D53AD357015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5648816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36EA1-2526-C744-AD56-14DE8A8A7FBC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幻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85DF5-F796-DC4E-85AF-D53AD357015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0637684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36EA1-2526-C744-AD56-14DE8A8A7FBC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85DF5-F796-DC4E-85AF-D53AD357015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261091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36EA1-2526-C744-AD56-14DE8A8A7FBC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85DF5-F796-DC4E-85AF-D53AD357015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3790882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36EA1-2526-C744-AD56-14DE8A8A7FBC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85DF5-F796-DC4E-85AF-D53AD357015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8732825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E36EA1-2526-C744-AD56-14DE8A8A7FBC}" type="datetimeFigureOut">
              <a:rPr kumimoji="1" lang="zh-CN" altLang="en-US" smtClean="0"/>
              <a:t>6/4/1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985DF5-F796-DC4E-85AF-D53AD357015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6605621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表格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84526587"/>
              </p:ext>
            </p:extLst>
          </p:nvPr>
        </p:nvGraphicFramePr>
        <p:xfrm>
          <a:off x="1460500" y="2273987"/>
          <a:ext cx="5359400" cy="1049020"/>
        </p:xfrm>
        <a:graphic>
          <a:graphicData uri="http://schemas.openxmlformats.org/drawingml/2006/table">
            <a:tbl>
              <a:tblPr/>
              <a:tblGrid>
                <a:gridCol w="1409700"/>
                <a:gridCol w="1913467"/>
                <a:gridCol w="2036233"/>
              </a:tblGrid>
              <a:tr h="119182"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NP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00000"/>
                        </a:lnSpc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orward primer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00000"/>
                        </a:lnSpc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everse primer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9182"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00000"/>
                        </a:lnSpc>
                      </a:pP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00000"/>
                        </a:lnSpc>
                      </a:pP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9182"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B27 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rs13202464)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00000"/>
                        </a:lnSpc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CTACGCACAGAATGAGACG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00000"/>
                        </a:lnSpc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TGGGTGACTATGTATTTGAGAC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19182"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LA-B27 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rs116488202)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00000"/>
                        </a:lnSpc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TGATTAGGTCTATCCAATGGTG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00000"/>
                        </a:lnSpc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GTGTGCAACTCCCGAATAG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182"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p15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(rs6759298)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00000"/>
                        </a:lnSpc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TGGGTCCTGATGTCCCTGTT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00000"/>
                        </a:lnSpc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TCACCAGGTCTGTGGAATGC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4234"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RAP1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(rs30187)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00000"/>
                        </a:lnSpc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AGCAAGGTTCCATCCTACAAG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00000"/>
                        </a:lnSpc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GAAAGGGATCAGAAAGTGCTC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182"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9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L23R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(rs11209026)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00000"/>
                        </a:lnSpc>
                      </a:pPr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ACAACAGAGGAGACATTGGAC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>
                        <a:lnSpc>
                          <a:spcPct val="100000"/>
                        </a:lnSpc>
                      </a:pP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TGTAGAGAGTTTGGCATGGGTAAG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45169172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办公室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办公室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办公室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9</Words>
  <Application>Microsoft Macintosh PowerPoint</Application>
  <PresentationFormat>全屏显示(4:3)</PresentationFormat>
  <Paragraphs>18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Company>中南大学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ong Ma</dc:creator>
  <cp:lastModifiedBy>Long Ma</cp:lastModifiedBy>
  <cp:revision>1</cp:revision>
  <dcterms:created xsi:type="dcterms:W3CDTF">2018-06-04T06:26:21Z</dcterms:created>
  <dcterms:modified xsi:type="dcterms:W3CDTF">2018-06-04T06:27:10Z</dcterms:modified>
</cp:coreProperties>
</file>